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77" d="100"/>
          <a:sy n="77" d="100"/>
        </p:scale>
        <p:origin x="23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9E42F07-C2A5-4AAD-A010-9CC47B8AAC3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2CE140BA-A309-401A-82F8-7685DD4C0FC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0129096-A7EB-4FE9-B069-4B84C33427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266C737-0E86-4F5C-B6E4-7F5E0AFB95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FBE8D936-6A00-4873-A9DA-F98E9D31DD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000044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28A2D6-C2F0-4A09-92B9-5BCEDAD4D2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E296644-28B8-49B1-B955-53D2CCACFF3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530FF7-BAC7-42DD-91FE-6F3444E084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C56BA64-BAD1-471A-BA36-955AB599C0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4E8C008-2DC6-4B44-813F-1623C0B03A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5358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4F873F4-DBD9-4242-93DD-36124F9076D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E16AE6D-1D3F-4825-9347-5653873C69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335FD8F-0FF8-47D9-B9CC-C77CA0554C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EC85DAC-EB41-400A-BB12-CA23B58EE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53D6DDB-BD4A-41CB-A9D0-4694FAB840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276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589C355-A025-4D2F-AAEA-160A26D8BD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9EDE80BA-CE3E-4288-8CFD-1C688498A21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77FE365-4EEB-4282-BD45-1728FE353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081D9C1-9EE9-4352-AEFC-7BE65CFEB7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6E51928-0D34-490D-A7B3-DA5FB07A3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966005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89787DA-3325-4890-BAE3-FFDBBE002A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6846B4-7898-4D58-B453-762E984966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3F93933-95C7-4FE1-BAAE-E2A644F764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27ECD616-ABE7-4E5C-A5A7-849FC87821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ECD044F0-9EA9-4E76-BB34-387E884962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504393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5139671-DC36-4A5F-A98F-C035DFBB35B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C0BF267-1202-4C63-B14F-EC2566B7BEF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F573798-2D30-4028-B3C8-575FF878014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D2BB50C-2981-48DE-B05D-E3711FC308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397CFFE-8129-4560-BA0A-9280CC8763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0A2B23C-F069-4351-A434-45569C6FC6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288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DBD2B87-DF9C-4B17-BB5C-71EDA29F8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175E94C2-80CF-4F9E-83E5-8D550DB4B69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BB892BD5-7CC3-4977-A9A6-7830E53BD42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C784982-E8EA-4C74-8FBB-7D235A289660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2BBFB01-2335-4CD0-844F-202E15DECAB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33FDF6E-E54E-44B4-BD10-055BD02E04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FB772BC8-670D-45BC-B876-A9269CA741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91F0561F-CC93-41B4-BA22-E4F3522F8B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63630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1228DB7-4016-4AEF-AE87-552247535A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E2785BA9-856A-422C-BD7B-F09063945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70D8D044-4603-47F1-AF93-E8ED4B60BA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EAB031A1-4816-4666-BCBB-9C23A25562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41473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F25A7A6-0DD2-4291-A156-56A5A665A4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ECEC822-3FB3-4774-A048-EF9D0557C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46503A8-8E80-4F67-BCE4-BD1C13CF5D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365071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92022B0-0DC5-48B4-8C32-C0E6642F94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5875C395-F8AD-445B-AE94-09CB88D76CC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CAE769D2-B8F4-4D15-A352-F8F124C5F21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AC41AF11-77CE-42D7-A52F-AC6E1F010C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5635A2B-3FCD-4970-A7F4-67B111AB67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7029681-EAF4-4437-97F6-856FFB00D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7869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642D997F-28B4-4CA2-B12D-ADB9E4012D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46B6AE1F-A6F5-4996-BE38-AF50B9C8DFC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4D6C379-108E-4107-86B1-A2445FF56F1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AFE0198-5A03-46AB-A169-4C525C6544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F6AE5026-859B-4A01-88E8-3F38A14387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E96C5BEB-FD53-4C59-94CA-2FF5D496CC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724665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0DA3E028-D8DD-42F4-A68E-CD571D985F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904CBE8-AE61-4904-ACFE-847FCBACC1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675A65E-BA0F-40D7-AA25-673C5EB8591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13D07A-9089-408B-8E8E-BA693F13FF55}" type="datetimeFigureOut">
              <a:rPr kumimoji="1" lang="ja-JP" altLang="en-US" smtClean="0"/>
              <a:t>2021/6/1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FC797E4F-2B95-4AD0-822B-3B037F8ECE0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B025E1C-9C9A-44B9-9F39-D11A046CC4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646258-02FB-4568-B147-34019E8C3F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296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E9EAB292-1B6D-48BF-BCAB-C3DB1A844FA6}"/>
              </a:ext>
            </a:extLst>
          </p:cNvPr>
          <p:cNvSpPr txBox="1"/>
          <p:nvPr/>
        </p:nvSpPr>
        <p:spPr>
          <a:xfrm>
            <a:off x="154464" y="264866"/>
            <a:ext cx="321594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/>
              <a:t>Supplemental Figure </a:t>
            </a:r>
            <a:endParaRPr kumimoji="1" lang="ja-JP" altLang="en-US" sz="24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D35B281B-06F2-4AB2-90EA-0DB49480F4D9}"/>
              </a:ext>
            </a:extLst>
          </p:cNvPr>
          <p:cNvSpPr txBox="1"/>
          <p:nvPr/>
        </p:nvSpPr>
        <p:spPr>
          <a:xfrm>
            <a:off x="154464" y="798677"/>
            <a:ext cx="1013290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Relationship between each immune cells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in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primary</a:t>
            </a:r>
            <a:r>
              <a:rPr kumimoji="1" lang="ja-JP" altLang="en-US" sz="2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kumimoji="1" lang="en-US" altLang="ja-JP" sz="2000" dirty="0">
                <a:latin typeface="Arial" panose="020B0604020202020204" pitchFamily="34" charset="0"/>
                <a:cs typeface="Arial" panose="020B0604020202020204" pitchFamily="34" charset="0"/>
              </a:rPr>
              <a:t>lesion and progression free survival</a:t>
            </a:r>
            <a:endParaRPr kumimoji="1" lang="ja-JP" altLang="en-US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4" name="図 63" descr="ダイアグラム, 概略図&#10;&#10;自動的に生成された説明">
            <a:extLst>
              <a:ext uri="{FF2B5EF4-FFF2-40B4-BE49-F238E27FC236}">
                <a16:creationId xmlns:a16="http://schemas.microsoft.com/office/drawing/2014/main" id="{2D6961E6-C520-4B9A-A4AF-5F34080BDBD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323736"/>
            <a:ext cx="12192000" cy="55342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014162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4</Words>
  <Application>Microsoft Office PowerPoint</Application>
  <PresentationFormat>ワイド画面</PresentationFormat>
  <Paragraphs>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游ゴシック</vt:lpstr>
      <vt:lpstr>游ゴシック Light</vt:lpstr>
      <vt:lpstr>Arial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大樹 五十嵐</dc:creator>
  <cp:lastModifiedBy>大樹 五十嵐</cp:lastModifiedBy>
  <cp:revision>2</cp:revision>
  <dcterms:created xsi:type="dcterms:W3CDTF">2021-06-08T03:13:53Z</dcterms:created>
  <dcterms:modified xsi:type="dcterms:W3CDTF">2021-06-11T12:08:26Z</dcterms:modified>
</cp:coreProperties>
</file>